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94"/>
  </p:normalViewPr>
  <p:slideViewPr>
    <p:cSldViewPr snapToGrid="0" snapToObjects="1">
      <p:cViewPr varScale="1">
        <p:scale>
          <a:sx n="80" d="100"/>
          <a:sy n="80" d="100"/>
        </p:scale>
        <p:origin x="1680" y="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holder, Gabriel D" userId="cc73c057-cf19-4f04-bd58-fa62d1beb7db" providerId="ADAL" clId="{7E472E91-2C81-404A-A1F0-8F2B8EA5282F}"/>
    <pc:docChg chg="delSld modSld">
      <pc:chgData name="Sholder, Gabriel D" userId="cc73c057-cf19-4f04-bd58-fa62d1beb7db" providerId="ADAL" clId="{7E472E91-2C81-404A-A1F0-8F2B8EA5282F}" dt="2019-08-15T17:55:51.902" v="17" actId="20577"/>
      <pc:docMkLst>
        <pc:docMk/>
      </pc:docMkLst>
      <pc:sldChg chg="del">
        <pc:chgData name="Sholder, Gabriel D" userId="cc73c057-cf19-4f04-bd58-fa62d1beb7db" providerId="ADAL" clId="{7E472E91-2C81-404A-A1F0-8F2B8EA5282F}" dt="2019-08-15T14:48:37.218" v="0" actId="2696"/>
        <pc:sldMkLst>
          <pc:docMk/>
          <pc:sldMk cId="3961732174" sldId="256"/>
        </pc:sldMkLst>
      </pc:sldChg>
      <pc:sldChg chg="modSp">
        <pc:chgData name="Sholder, Gabriel D" userId="cc73c057-cf19-4f04-bd58-fa62d1beb7db" providerId="ADAL" clId="{7E472E91-2C81-404A-A1F0-8F2B8EA5282F}" dt="2019-08-15T17:55:51.902" v="17" actId="20577"/>
        <pc:sldMkLst>
          <pc:docMk/>
          <pc:sldMk cId="1596923740" sldId="257"/>
        </pc:sldMkLst>
        <pc:spChg chg="mod">
          <ac:chgData name="Sholder, Gabriel D" userId="cc73c057-cf19-4f04-bd58-fa62d1beb7db" providerId="ADAL" clId="{7E472E91-2C81-404A-A1F0-8F2B8EA5282F}" dt="2019-08-15T17:55:51.902" v="17" actId="20577"/>
          <ac:spMkLst>
            <pc:docMk/>
            <pc:sldMk cId="1596923740" sldId="257"/>
            <ac:spMk id="12" creationId="{1F800075-7DE7-9546-8D5A-E808C70F84A0}"/>
          </ac:spMkLst>
        </pc:spChg>
      </pc:sldChg>
      <pc:sldChg chg="del">
        <pc:chgData name="Sholder, Gabriel D" userId="cc73c057-cf19-4f04-bd58-fa62d1beb7db" providerId="ADAL" clId="{7E472E91-2C81-404A-A1F0-8F2B8EA5282F}" dt="2019-08-15T14:48:43.323" v="1" actId="2696"/>
        <pc:sldMkLst>
          <pc:docMk/>
          <pc:sldMk cId="924217279" sldId="258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10183-161B-8947-9A3D-2CE8275EDD70}" type="datetimeFigureOut">
              <a:rPr lang="en-US" smtClean="0"/>
              <a:t>8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0B59E4-6A9E-8B4A-AD95-52AB03F960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94265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10183-161B-8947-9A3D-2CE8275EDD70}" type="datetimeFigureOut">
              <a:rPr lang="en-US" smtClean="0"/>
              <a:t>8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0B59E4-6A9E-8B4A-AD95-52AB03F960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31986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10183-161B-8947-9A3D-2CE8275EDD70}" type="datetimeFigureOut">
              <a:rPr lang="en-US" smtClean="0"/>
              <a:t>8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0B59E4-6A9E-8B4A-AD95-52AB03F960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41158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10183-161B-8947-9A3D-2CE8275EDD70}" type="datetimeFigureOut">
              <a:rPr lang="en-US" smtClean="0"/>
              <a:t>8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0B59E4-6A9E-8B4A-AD95-52AB03F960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46569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10183-161B-8947-9A3D-2CE8275EDD70}" type="datetimeFigureOut">
              <a:rPr lang="en-US" smtClean="0"/>
              <a:t>8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0B59E4-6A9E-8B4A-AD95-52AB03F960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25078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10183-161B-8947-9A3D-2CE8275EDD70}" type="datetimeFigureOut">
              <a:rPr lang="en-US" smtClean="0"/>
              <a:t>8/15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0B59E4-6A9E-8B4A-AD95-52AB03F960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29490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10183-161B-8947-9A3D-2CE8275EDD70}" type="datetimeFigureOut">
              <a:rPr lang="en-US" smtClean="0"/>
              <a:t>8/15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0B59E4-6A9E-8B4A-AD95-52AB03F960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62240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10183-161B-8947-9A3D-2CE8275EDD70}" type="datetimeFigureOut">
              <a:rPr lang="en-US" smtClean="0"/>
              <a:t>8/15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0B59E4-6A9E-8B4A-AD95-52AB03F960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30521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10183-161B-8947-9A3D-2CE8275EDD70}" type="datetimeFigureOut">
              <a:rPr lang="en-US" smtClean="0"/>
              <a:t>8/15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0B59E4-6A9E-8B4A-AD95-52AB03F960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21731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10183-161B-8947-9A3D-2CE8275EDD70}" type="datetimeFigureOut">
              <a:rPr lang="en-US" smtClean="0"/>
              <a:t>8/15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0B59E4-6A9E-8B4A-AD95-52AB03F960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8291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10183-161B-8947-9A3D-2CE8275EDD70}" type="datetimeFigureOut">
              <a:rPr lang="en-US" smtClean="0"/>
              <a:t>8/15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0B59E4-6A9E-8B4A-AD95-52AB03F960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07455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110183-161B-8947-9A3D-2CE8275EDD70}" type="datetimeFigureOut">
              <a:rPr lang="en-US" smtClean="0"/>
              <a:t>8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0B59E4-6A9E-8B4A-AD95-52AB03F960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50342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F6A5341E-92AA-744A-8B8B-ABE1F0E8666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4048" b="3862"/>
          <a:stretch/>
        </p:blipFill>
        <p:spPr>
          <a:xfrm>
            <a:off x="597340" y="3246282"/>
            <a:ext cx="2649155" cy="2398013"/>
          </a:xfrm>
          <a:prstGeom prst="rect">
            <a:avLst/>
          </a:prstGeom>
        </p:spPr>
      </p:pic>
      <p:sp>
        <p:nvSpPr>
          <p:cNvPr id="5" name="Oval 4">
            <a:extLst>
              <a:ext uri="{FF2B5EF4-FFF2-40B4-BE49-F238E27FC236}">
                <a16:creationId xmlns:a16="http://schemas.microsoft.com/office/drawing/2014/main" id="{589B3E29-C664-134B-9E6D-48E4351A95F9}"/>
              </a:ext>
            </a:extLst>
          </p:cNvPr>
          <p:cNvSpPr/>
          <p:nvPr/>
        </p:nvSpPr>
        <p:spPr>
          <a:xfrm>
            <a:off x="1588237" y="1579983"/>
            <a:ext cx="1410002" cy="803116"/>
          </a:xfrm>
          <a:prstGeom prst="ellipse">
            <a:avLst/>
          </a:prstGeom>
          <a:solidFill>
            <a:srgbClr val="FFFFFF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Oval 5">
            <a:extLst>
              <a:ext uri="{FF2B5EF4-FFF2-40B4-BE49-F238E27FC236}">
                <a16:creationId xmlns:a16="http://schemas.microsoft.com/office/drawing/2014/main" id="{66C47473-A1C2-4941-BF9B-A6225EF5CB5E}"/>
              </a:ext>
            </a:extLst>
          </p:cNvPr>
          <p:cNvSpPr/>
          <p:nvPr/>
        </p:nvSpPr>
        <p:spPr>
          <a:xfrm>
            <a:off x="2207525" y="1579983"/>
            <a:ext cx="1410002" cy="803116"/>
          </a:xfrm>
          <a:prstGeom prst="ellipse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61D18C5-FC87-4941-8277-822D95BD6762}"/>
              </a:ext>
            </a:extLst>
          </p:cNvPr>
          <p:cNvSpPr txBox="1"/>
          <p:nvPr/>
        </p:nvSpPr>
        <p:spPr>
          <a:xfrm>
            <a:off x="1538917" y="1115495"/>
            <a:ext cx="8410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TruSeq</a:t>
            </a:r>
            <a:endParaRPr lang="en-US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4C3B1A1-798B-3C41-9FD5-6991E69DECDD}"/>
              </a:ext>
            </a:extLst>
          </p:cNvPr>
          <p:cNvSpPr txBox="1"/>
          <p:nvPr/>
        </p:nvSpPr>
        <p:spPr>
          <a:xfrm>
            <a:off x="2442206" y="1757416"/>
            <a:ext cx="4186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54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0E6193F-6ED6-BC4E-B0AA-766CC2633165}"/>
              </a:ext>
            </a:extLst>
          </p:cNvPr>
          <p:cNvSpPr txBox="1"/>
          <p:nvPr/>
        </p:nvSpPr>
        <p:spPr>
          <a:xfrm>
            <a:off x="2998239" y="1748077"/>
            <a:ext cx="4186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33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E3A06FB-FD65-8E4F-B57B-4E0351C3799C}"/>
              </a:ext>
            </a:extLst>
          </p:cNvPr>
          <p:cNvSpPr txBox="1"/>
          <p:nvPr/>
        </p:nvSpPr>
        <p:spPr>
          <a:xfrm>
            <a:off x="1671877" y="1760399"/>
            <a:ext cx="5356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40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A43DDFD-A7AD-AF46-AF4C-04FA2C350AEC}"/>
              </a:ext>
            </a:extLst>
          </p:cNvPr>
          <p:cNvSpPr txBox="1"/>
          <p:nvPr/>
        </p:nvSpPr>
        <p:spPr>
          <a:xfrm>
            <a:off x="2747570" y="1115495"/>
            <a:ext cx="11720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3’Pool-seq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1F800075-7DE7-9546-8D5A-E808C70F84A0}"/>
              </a:ext>
            </a:extLst>
          </p:cNvPr>
          <p:cNvSpPr txBox="1"/>
          <p:nvPr/>
        </p:nvSpPr>
        <p:spPr>
          <a:xfrm>
            <a:off x="4506734" y="1579983"/>
            <a:ext cx="3729034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err="1"/>
              <a:t>TruSeq</a:t>
            </a:r>
            <a:r>
              <a:rPr lang="en-US" sz="1600" dirty="0"/>
              <a:t> hits: </a:t>
            </a:r>
            <a:r>
              <a:rPr lang="en-US" sz="1600" dirty="0" err="1"/>
              <a:t>qval</a:t>
            </a:r>
            <a:r>
              <a:rPr lang="en-US" sz="1600" dirty="0"/>
              <a:t>&lt;0.05, </a:t>
            </a:r>
            <a:r>
              <a:rPr lang="en-US" sz="1600" dirty="0">
                <a:solidFill>
                  <a:srgbClr val="000000"/>
                </a:solidFill>
                <a:ea typeface="Calibri"/>
                <a:cs typeface="Calibri"/>
              </a:rPr>
              <a:t>absolute(</a:t>
            </a:r>
            <a:r>
              <a:rPr lang="en-US" sz="1600">
                <a:solidFill>
                  <a:srgbClr val="000000"/>
                </a:solidFill>
                <a:ea typeface="Calibri"/>
                <a:cs typeface="Calibri"/>
              </a:rPr>
              <a:t>log</a:t>
            </a:r>
            <a:r>
              <a:rPr lang="en-US" sz="1600" baseline="-25000">
                <a:solidFill>
                  <a:srgbClr val="000000"/>
                </a:solidFill>
                <a:ea typeface="Calibri"/>
                <a:cs typeface="Calibri"/>
              </a:rPr>
              <a:t>2</a:t>
            </a:r>
            <a:r>
              <a:rPr lang="en-US" sz="1600">
                <a:solidFill>
                  <a:srgbClr val="000000"/>
                </a:solidFill>
                <a:ea typeface="Calibri"/>
                <a:cs typeface="Calibri"/>
              </a:rPr>
              <a:t>FC &gt;1)</a:t>
            </a:r>
            <a:endParaRPr lang="en-US" sz="1600" dirty="0">
              <a:solidFill>
                <a:srgbClr val="000000"/>
              </a:solidFill>
              <a:ea typeface="Calibri"/>
              <a:cs typeface="Calibri"/>
            </a:endParaRPr>
          </a:p>
          <a:p>
            <a:r>
              <a:rPr lang="en-US" sz="1600" dirty="0">
                <a:solidFill>
                  <a:srgbClr val="000000"/>
                </a:solidFill>
                <a:ea typeface="Calibri"/>
                <a:cs typeface="Calibri"/>
              </a:rPr>
              <a:t>3’Pool-seq: </a:t>
            </a:r>
            <a:r>
              <a:rPr lang="en-US" sz="1600" dirty="0" err="1"/>
              <a:t>qval</a:t>
            </a:r>
            <a:r>
              <a:rPr lang="en-US" sz="1600" dirty="0"/>
              <a:t>&lt;0.1, </a:t>
            </a:r>
            <a:r>
              <a:rPr lang="en-US" sz="1600" dirty="0">
                <a:solidFill>
                  <a:srgbClr val="000000"/>
                </a:solidFill>
                <a:ea typeface="Calibri"/>
                <a:cs typeface="Calibri"/>
              </a:rPr>
              <a:t>absolute(log</a:t>
            </a:r>
            <a:r>
              <a:rPr lang="en-US" sz="1600" baseline="-25000" dirty="0">
                <a:solidFill>
                  <a:srgbClr val="000000"/>
                </a:solidFill>
                <a:ea typeface="Calibri"/>
                <a:cs typeface="Calibri"/>
              </a:rPr>
              <a:t>2</a:t>
            </a:r>
            <a:r>
              <a:rPr lang="en-US" sz="1600" dirty="0">
                <a:solidFill>
                  <a:srgbClr val="000000"/>
                </a:solidFill>
                <a:ea typeface="Calibri"/>
                <a:cs typeface="Calibri"/>
              </a:rPr>
              <a:t>FC &gt;1.5)</a:t>
            </a: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82E1C5F7-7779-E84C-94AD-F4C9B165D83C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523" b="4541"/>
          <a:stretch/>
        </p:blipFill>
        <p:spPr>
          <a:xfrm>
            <a:off x="3608615" y="3317796"/>
            <a:ext cx="2597187" cy="2293404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0DCCC8B8-B393-0F4D-BE2F-F7E7B1C15FFD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3568" b="4282"/>
          <a:stretch/>
        </p:blipFill>
        <p:spPr>
          <a:xfrm>
            <a:off x="6525995" y="3307637"/>
            <a:ext cx="2525451" cy="2270468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1188029" y="5689574"/>
            <a:ext cx="64633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/>
              <a:t>Mean TPM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4063813" y="5689574"/>
            <a:ext cx="9990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/>
              <a:t>Length (base-pairs)</a:t>
            </a:r>
          </a:p>
          <a:p>
            <a:endParaRPr lang="en-US" sz="800" b="1" dirty="0"/>
          </a:p>
        </p:txBody>
      </p:sp>
      <p:sp>
        <p:nvSpPr>
          <p:cNvPr id="17" name="TextBox 16"/>
          <p:cNvSpPr txBox="1"/>
          <p:nvPr/>
        </p:nvSpPr>
        <p:spPr>
          <a:xfrm>
            <a:off x="6806589" y="5689574"/>
            <a:ext cx="136863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/>
              <a:t>Absolute (log</a:t>
            </a:r>
            <a:r>
              <a:rPr lang="en-US" sz="800" b="1" baseline="-25000" dirty="0"/>
              <a:t>2</a:t>
            </a:r>
            <a:r>
              <a:rPr lang="en-US" sz="800" b="1" dirty="0"/>
              <a:t> Fold-Change)</a:t>
            </a:r>
          </a:p>
        </p:txBody>
      </p:sp>
      <p:sp>
        <p:nvSpPr>
          <p:cNvPr id="18" name="TextBox 17"/>
          <p:cNvSpPr txBox="1"/>
          <p:nvPr/>
        </p:nvSpPr>
        <p:spPr>
          <a:xfrm rot="16200000">
            <a:off x="191625" y="4362794"/>
            <a:ext cx="50526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/>
              <a:t>Density</a:t>
            </a:r>
          </a:p>
        </p:txBody>
      </p:sp>
      <p:sp>
        <p:nvSpPr>
          <p:cNvPr id="19" name="TextBox 18"/>
          <p:cNvSpPr txBox="1"/>
          <p:nvPr/>
        </p:nvSpPr>
        <p:spPr>
          <a:xfrm rot="16200000">
            <a:off x="3255027" y="4362793"/>
            <a:ext cx="50526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Density</a:t>
            </a:r>
          </a:p>
        </p:txBody>
      </p:sp>
      <p:sp>
        <p:nvSpPr>
          <p:cNvPr id="20" name="TextBox 19"/>
          <p:cNvSpPr txBox="1"/>
          <p:nvPr/>
        </p:nvSpPr>
        <p:spPr>
          <a:xfrm rot="16200000">
            <a:off x="6139306" y="4362795"/>
            <a:ext cx="50526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/>
              <a:t>Density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551981" y="456172"/>
            <a:ext cx="3765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.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551981" y="2692171"/>
            <a:ext cx="368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.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1188029" y="751530"/>
            <a:ext cx="29467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ifferentially Detected Genes</a:t>
            </a:r>
          </a:p>
        </p:txBody>
      </p:sp>
    </p:spTree>
    <p:extLst>
      <p:ext uri="{BB962C8B-B14F-4D97-AF65-F5344CB8AC3E}">
        <p14:creationId xmlns:p14="http://schemas.microsoft.com/office/powerpoint/2010/main" val="15969237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76</TotalTime>
  <Words>51</Words>
  <Application>Microsoft Office PowerPoint</Application>
  <PresentationFormat>On-screen Show (4:3)</PresentationFormat>
  <Paragraphs>1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AbbVi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imon Xi</dc:creator>
  <cp:lastModifiedBy>Sholder, Gabriel D</cp:lastModifiedBy>
  <cp:revision>17</cp:revision>
  <dcterms:created xsi:type="dcterms:W3CDTF">2019-07-15T20:24:05Z</dcterms:created>
  <dcterms:modified xsi:type="dcterms:W3CDTF">2019-08-15T17:55:53Z</dcterms:modified>
</cp:coreProperties>
</file>